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7"/>
  </p:notesMasterIdLst>
  <p:sldIdLst>
    <p:sldId id="339" r:id="rId2"/>
    <p:sldId id="366" r:id="rId3"/>
    <p:sldId id="351" r:id="rId4"/>
    <p:sldId id="352" r:id="rId5"/>
    <p:sldId id="353" r:id="rId6"/>
    <p:sldId id="354" r:id="rId7"/>
    <p:sldId id="367" r:id="rId8"/>
    <p:sldId id="386" r:id="rId9"/>
    <p:sldId id="387" r:id="rId10"/>
    <p:sldId id="388" r:id="rId11"/>
    <p:sldId id="384" r:id="rId12"/>
    <p:sldId id="381" r:id="rId13"/>
    <p:sldId id="385" r:id="rId14"/>
    <p:sldId id="361" r:id="rId15"/>
    <p:sldId id="345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0633" autoAdjust="0"/>
    <p:restoredTop sz="94660"/>
  </p:normalViewPr>
  <p:slideViewPr>
    <p:cSldViewPr snapToGrid="0">
      <p:cViewPr varScale="1">
        <p:scale>
          <a:sx n="56" d="100"/>
          <a:sy n="56" d="100"/>
        </p:scale>
        <p:origin x="116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40" d="100"/>
        <a:sy n="4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akraborty, Nabarun CIV DHA WRAIR (USA)" userId="62fed071-c20e-4cbc-9e02-4f72231ed22b" providerId="ADAL" clId="{83351D41-DF4F-441B-919F-1FEE7BC3C290}"/>
    <pc:docChg chg="delSld">
      <pc:chgData name="Chakraborty, Nabarun CIV DHA WRAIR (USA)" userId="62fed071-c20e-4cbc-9e02-4f72231ed22b" providerId="ADAL" clId="{83351D41-DF4F-441B-919F-1FEE7BC3C290}" dt="2025-04-22T02:38:11.583" v="1" actId="47"/>
      <pc:docMkLst>
        <pc:docMk/>
      </pc:docMkLst>
      <pc:sldChg chg="del">
        <pc:chgData name="Chakraborty, Nabarun CIV DHA WRAIR (USA)" userId="62fed071-c20e-4cbc-9e02-4f72231ed22b" providerId="ADAL" clId="{83351D41-DF4F-441B-919F-1FEE7BC3C290}" dt="2025-04-22T02:38:09.417" v="0" actId="47"/>
        <pc:sldMkLst>
          <pc:docMk/>
          <pc:sldMk cId="2173421952" sldId="338"/>
        </pc:sldMkLst>
      </pc:sldChg>
      <pc:sldChg chg="del">
        <pc:chgData name="Chakraborty, Nabarun CIV DHA WRAIR (USA)" userId="62fed071-c20e-4cbc-9e02-4f72231ed22b" providerId="ADAL" clId="{83351D41-DF4F-441B-919F-1FEE7BC3C290}" dt="2025-04-22T02:38:09.417" v="0" actId="47"/>
        <pc:sldMkLst>
          <pc:docMk/>
          <pc:sldMk cId="1455735021" sldId="349"/>
        </pc:sldMkLst>
      </pc:sldChg>
      <pc:sldChg chg="del">
        <pc:chgData name="Chakraborty, Nabarun CIV DHA WRAIR (USA)" userId="62fed071-c20e-4cbc-9e02-4f72231ed22b" providerId="ADAL" clId="{83351D41-DF4F-441B-919F-1FEE7BC3C290}" dt="2025-04-22T02:38:09.417" v="0" actId="47"/>
        <pc:sldMkLst>
          <pc:docMk/>
          <pc:sldMk cId="4219652331" sldId="355"/>
        </pc:sldMkLst>
      </pc:sldChg>
      <pc:sldChg chg="del">
        <pc:chgData name="Chakraborty, Nabarun CIV DHA WRAIR (USA)" userId="62fed071-c20e-4cbc-9e02-4f72231ed22b" providerId="ADAL" clId="{83351D41-DF4F-441B-919F-1FEE7BC3C290}" dt="2025-04-22T02:38:09.417" v="0" actId="47"/>
        <pc:sldMkLst>
          <pc:docMk/>
          <pc:sldMk cId="2335634049" sldId="356"/>
        </pc:sldMkLst>
      </pc:sldChg>
      <pc:sldChg chg="del">
        <pc:chgData name="Chakraborty, Nabarun CIV DHA WRAIR (USA)" userId="62fed071-c20e-4cbc-9e02-4f72231ed22b" providerId="ADAL" clId="{83351D41-DF4F-441B-919F-1FEE7BC3C290}" dt="2025-04-22T02:38:09.417" v="0" actId="47"/>
        <pc:sldMkLst>
          <pc:docMk/>
          <pc:sldMk cId="1565576541" sldId="360"/>
        </pc:sldMkLst>
      </pc:sldChg>
      <pc:sldChg chg="del">
        <pc:chgData name="Chakraborty, Nabarun CIV DHA WRAIR (USA)" userId="62fed071-c20e-4cbc-9e02-4f72231ed22b" providerId="ADAL" clId="{83351D41-DF4F-441B-919F-1FEE7BC3C290}" dt="2025-04-22T02:38:09.417" v="0" actId="47"/>
        <pc:sldMkLst>
          <pc:docMk/>
          <pc:sldMk cId="1113132833" sldId="364"/>
        </pc:sldMkLst>
      </pc:sldChg>
      <pc:sldChg chg="del">
        <pc:chgData name="Chakraborty, Nabarun CIV DHA WRAIR (USA)" userId="62fed071-c20e-4cbc-9e02-4f72231ed22b" providerId="ADAL" clId="{83351D41-DF4F-441B-919F-1FEE7BC3C290}" dt="2025-04-22T02:38:09.417" v="0" actId="47"/>
        <pc:sldMkLst>
          <pc:docMk/>
          <pc:sldMk cId="1976724288" sldId="372"/>
        </pc:sldMkLst>
      </pc:sldChg>
      <pc:sldChg chg="del">
        <pc:chgData name="Chakraborty, Nabarun CIV DHA WRAIR (USA)" userId="62fed071-c20e-4cbc-9e02-4f72231ed22b" providerId="ADAL" clId="{83351D41-DF4F-441B-919F-1FEE7BC3C290}" dt="2025-04-22T02:38:09.417" v="0" actId="47"/>
        <pc:sldMkLst>
          <pc:docMk/>
          <pc:sldMk cId="82324647" sldId="373"/>
        </pc:sldMkLst>
      </pc:sldChg>
      <pc:sldChg chg="del">
        <pc:chgData name="Chakraborty, Nabarun CIV DHA WRAIR (USA)" userId="62fed071-c20e-4cbc-9e02-4f72231ed22b" providerId="ADAL" clId="{83351D41-DF4F-441B-919F-1FEE7BC3C290}" dt="2025-04-22T02:38:09.417" v="0" actId="47"/>
        <pc:sldMkLst>
          <pc:docMk/>
          <pc:sldMk cId="942924960" sldId="378"/>
        </pc:sldMkLst>
      </pc:sldChg>
      <pc:sldChg chg="del">
        <pc:chgData name="Chakraborty, Nabarun CIV DHA WRAIR (USA)" userId="62fed071-c20e-4cbc-9e02-4f72231ed22b" providerId="ADAL" clId="{83351D41-DF4F-441B-919F-1FEE7BC3C290}" dt="2025-04-22T02:38:09.417" v="0" actId="47"/>
        <pc:sldMkLst>
          <pc:docMk/>
          <pc:sldMk cId="1364281301" sldId="382"/>
        </pc:sldMkLst>
      </pc:sldChg>
      <pc:sldChg chg="del">
        <pc:chgData name="Chakraborty, Nabarun CIV DHA WRAIR (USA)" userId="62fed071-c20e-4cbc-9e02-4f72231ed22b" providerId="ADAL" clId="{83351D41-DF4F-441B-919F-1FEE7BC3C290}" dt="2025-04-22T02:38:11.583" v="1" actId="47"/>
        <pc:sldMkLst>
          <pc:docMk/>
          <pc:sldMk cId="1701810031" sldId="38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DB6C9E-988D-4172-8537-E2D249F9F160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4816D6-6CF7-47BD-95CD-6F5847F49E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5275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F611E-C3AA-430A-B67E-F51C987ED517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6B6D-C4F5-4E2B-B0C2-9126033B2F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814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F611E-C3AA-430A-B67E-F51C987ED517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6B6D-C4F5-4E2B-B0C2-9126033B2F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544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F611E-C3AA-430A-B67E-F51C987ED517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6B6D-C4F5-4E2B-B0C2-9126033B2F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281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F611E-C3AA-430A-B67E-F51C987ED517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6B6D-C4F5-4E2B-B0C2-9126033B2F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196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F611E-C3AA-430A-B67E-F51C987ED517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6B6D-C4F5-4E2B-B0C2-9126033B2F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129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F611E-C3AA-430A-B67E-F51C987ED517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6B6D-C4F5-4E2B-B0C2-9126033B2F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6813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F611E-C3AA-430A-B67E-F51C987ED517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6B6D-C4F5-4E2B-B0C2-9126033B2F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268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F611E-C3AA-430A-B67E-F51C987ED517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6B6D-C4F5-4E2B-B0C2-9126033B2F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620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F611E-C3AA-430A-B67E-F51C987ED517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6B6D-C4F5-4E2B-B0C2-9126033B2F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4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F611E-C3AA-430A-B67E-F51C987ED517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6B6D-C4F5-4E2B-B0C2-9126033B2F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255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F611E-C3AA-430A-B67E-F51C987ED517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6B6D-C4F5-4E2B-B0C2-9126033B2F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2174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DF611E-C3AA-430A-B67E-F51C987ED517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3C6B6D-C4F5-4E2B-B0C2-9126033B2F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7518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1B06C82B-A657-C19D-59E8-517EBCB5D3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44809" y="183664"/>
            <a:ext cx="3941289" cy="2955967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310E46A7-BC55-61C3-0415-D3DEE565B9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2083" y="662128"/>
            <a:ext cx="6242652" cy="5781201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2EFF2326-3CF6-E2BC-3414-DA5E25E85E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44809" y="3639361"/>
            <a:ext cx="4185108" cy="313963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CE702CFC-AD89-D026-5028-212A775A1A27}"/>
              </a:ext>
            </a:extLst>
          </p:cNvPr>
          <p:cNvSpPr txBox="1"/>
          <p:nvPr/>
        </p:nvSpPr>
        <p:spPr>
          <a:xfrm>
            <a:off x="214729" y="45339"/>
            <a:ext cx="1234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A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47AF365-8179-BADF-9496-43539C9289F3}"/>
              </a:ext>
            </a:extLst>
          </p:cNvPr>
          <p:cNvSpPr txBox="1"/>
          <p:nvPr/>
        </p:nvSpPr>
        <p:spPr>
          <a:xfrm>
            <a:off x="6826102" y="103751"/>
            <a:ext cx="1225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B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9F728D0-1790-E85D-8405-25B8F6CA8A5C}"/>
              </a:ext>
            </a:extLst>
          </p:cNvPr>
          <p:cNvSpPr txBox="1"/>
          <p:nvPr/>
        </p:nvSpPr>
        <p:spPr>
          <a:xfrm>
            <a:off x="6827704" y="3270029"/>
            <a:ext cx="1223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C.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0E005712-47E8-48DE-D198-CA2C92B9D66F}"/>
              </a:ext>
            </a:extLst>
          </p:cNvPr>
          <p:cNvCxnSpPr/>
          <p:nvPr/>
        </p:nvCxnSpPr>
        <p:spPr>
          <a:xfrm>
            <a:off x="6826102" y="183664"/>
            <a:ext cx="0" cy="650421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AE4CD29D-AEEB-AA6B-8DE3-13172801893F}"/>
              </a:ext>
            </a:extLst>
          </p:cNvPr>
          <p:cNvCxnSpPr>
            <a:cxnSpLocks/>
          </p:cNvCxnSpPr>
          <p:nvPr/>
        </p:nvCxnSpPr>
        <p:spPr>
          <a:xfrm flipH="1">
            <a:off x="6826102" y="3256589"/>
            <a:ext cx="518868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7964363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BCE7649D-3634-9B18-152F-59684D3F0B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4635" y="959293"/>
            <a:ext cx="5783264" cy="484801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C7D27DC-AAFA-F17F-6430-BB64DF15C8B1}"/>
              </a:ext>
            </a:extLst>
          </p:cNvPr>
          <p:cNvSpPr txBox="1"/>
          <p:nvPr/>
        </p:nvSpPr>
        <p:spPr>
          <a:xfrm>
            <a:off x="1667220" y="959293"/>
            <a:ext cx="12374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3D.</a:t>
            </a:r>
          </a:p>
        </p:txBody>
      </p:sp>
    </p:spTree>
    <p:extLst>
      <p:ext uri="{BB962C8B-B14F-4D97-AF65-F5344CB8AC3E}">
        <p14:creationId xmlns:p14="http://schemas.microsoft.com/office/powerpoint/2010/main" val="33051681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31B3C17-D73E-B6D1-EDB8-0DAD630452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1561" y="662026"/>
            <a:ext cx="6270068" cy="525609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21D1BB9-2120-40EF-FBEE-C0605EDA8187}"/>
              </a:ext>
            </a:extLst>
          </p:cNvPr>
          <p:cNvSpPr txBox="1"/>
          <p:nvPr/>
        </p:nvSpPr>
        <p:spPr>
          <a:xfrm>
            <a:off x="257259" y="662027"/>
            <a:ext cx="12123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3E.</a:t>
            </a:r>
          </a:p>
        </p:txBody>
      </p:sp>
    </p:spTree>
    <p:extLst>
      <p:ext uri="{BB962C8B-B14F-4D97-AF65-F5344CB8AC3E}">
        <p14:creationId xmlns:p14="http://schemas.microsoft.com/office/powerpoint/2010/main" val="299567732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val 3">
            <a:extLst>
              <a:ext uri="{FF2B5EF4-FFF2-40B4-BE49-F238E27FC236}">
                <a16:creationId xmlns:a16="http://schemas.microsoft.com/office/drawing/2014/main" id="{99A5FFAA-C023-3183-754A-F26167974FAF}"/>
              </a:ext>
            </a:extLst>
          </p:cNvPr>
          <p:cNvSpPr/>
          <p:nvPr/>
        </p:nvSpPr>
        <p:spPr>
          <a:xfrm>
            <a:off x="887882" y="2953639"/>
            <a:ext cx="1927394" cy="41664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1200" i="1" dirty="0">
                <a:solidFill>
                  <a:schemeClr val="tx1"/>
                </a:solidFill>
              </a:rPr>
              <a:t>Phyla: Actinobacteria</a:t>
            </a:r>
            <a:endParaRPr lang="en-US" sz="1200" dirty="0">
              <a:solidFill>
                <a:schemeClr val="tx1"/>
              </a:solidFill>
            </a:endParaRPr>
          </a:p>
        </p:txBody>
      </p:sp>
      <p:graphicFrame>
        <p:nvGraphicFramePr>
          <p:cNvPr id="7" name="Table 7">
            <a:extLst>
              <a:ext uri="{FF2B5EF4-FFF2-40B4-BE49-F238E27FC236}">
                <a16:creationId xmlns:a16="http://schemas.microsoft.com/office/drawing/2014/main" id="{8AF7656F-E39D-0E68-9D1C-9A83EC3A63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3969957"/>
              </p:ext>
            </p:extLst>
          </p:nvPr>
        </p:nvGraphicFramePr>
        <p:xfrm>
          <a:off x="4727359" y="2209800"/>
          <a:ext cx="5955526" cy="1219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37969">
                  <a:extLst>
                    <a:ext uri="{9D8B030D-6E8A-4147-A177-3AD203B41FA5}">
                      <a16:colId xmlns:a16="http://schemas.microsoft.com/office/drawing/2014/main" val="3411298828"/>
                    </a:ext>
                  </a:extLst>
                </a:gridCol>
                <a:gridCol w="572494">
                  <a:extLst>
                    <a:ext uri="{9D8B030D-6E8A-4147-A177-3AD203B41FA5}">
                      <a16:colId xmlns:a16="http://schemas.microsoft.com/office/drawing/2014/main" val="18510454"/>
                    </a:ext>
                  </a:extLst>
                </a:gridCol>
                <a:gridCol w="647957">
                  <a:extLst>
                    <a:ext uri="{9D8B030D-6E8A-4147-A177-3AD203B41FA5}">
                      <a16:colId xmlns:a16="http://schemas.microsoft.com/office/drawing/2014/main" val="1046743343"/>
                    </a:ext>
                  </a:extLst>
                </a:gridCol>
                <a:gridCol w="592667">
                  <a:extLst>
                    <a:ext uri="{9D8B030D-6E8A-4147-A177-3AD203B41FA5}">
                      <a16:colId xmlns:a16="http://schemas.microsoft.com/office/drawing/2014/main" val="62851186"/>
                    </a:ext>
                  </a:extLst>
                </a:gridCol>
                <a:gridCol w="508000">
                  <a:extLst>
                    <a:ext uri="{9D8B030D-6E8A-4147-A177-3AD203B41FA5}">
                      <a16:colId xmlns:a16="http://schemas.microsoft.com/office/drawing/2014/main" val="1024769821"/>
                    </a:ext>
                  </a:extLst>
                </a:gridCol>
                <a:gridCol w="397933">
                  <a:extLst>
                    <a:ext uri="{9D8B030D-6E8A-4147-A177-3AD203B41FA5}">
                      <a16:colId xmlns:a16="http://schemas.microsoft.com/office/drawing/2014/main" val="3141905695"/>
                    </a:ext>
                  </a:extLst>
                </a:gridCol>
                <a:gridCol w="540984">
                  <a:extLst>
                    <a:ext uri="{9D8B030D-6E8A-4147-A177-3AD203B41FA5}">
                      <a16:colId xmlns:a16="http://schemas.microsoft.com/office/drawing/2014/main" val="2080827118"/>
                    </a:ext>
                  </a:extLst>
                </a:gridCol>
                <a:gridCol w="508883">
                  <a:extLst>
                    <a:ext uri="{9D8B030D-6E8A-4147-A177-3AD203B41FA5}">
                      <a16:colId xmlns:a16="http://schemas.microsoft.com/office/drawing/2014/main" val="113462491"/>
                    </a:ext>
                  </a:extLst>
                </a:gridCol>
                <a:gridCol w="548639">
                  <a:extLst>
                    <a:ext uri="{9D8B030D-6E8A-4147-A177-3AD203B41FA5}">
                      <a16:colId xmlns:a16="http://schemas.microsoft.com/office/drawing/2014/main" val="270531452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endParaRPr lang="en-US" sz="10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Female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 sz="100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000" dirty="0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Mal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24485391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10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2">
                        <a:lumMod val="9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1m TSI</a:t>
                      </a: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1000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6m TSI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2">
                        <a:lumMod val="9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1000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1m TSI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2">
                        <a:lumMod val="9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1000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6m TSI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2">
                        <a:lumMod val="9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08901914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10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7Gy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tabLst>
                          <a:tab pos="457200" algn="l"/>
                        </a:tabLst>
                      </a:pPr>
                      <a:r>
                        <a:rPr lang="en-US" sz="1000" b="1" dirty="0"/>
                        <a:t>7.5Gy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7Gy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7.5Gy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7G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7.5Gy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7Gy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7.5Gy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842453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000" dirty="0"/>
                        <a:t> </a:t>
                      </a:r>
                      <a:r>
                        <a:rPr lang="en-US" sz="1000" dirty="0" err="1"/>
                        <a:t>heterolactic</a:t>
                      </a:r>
                      <a:r>
                        <a:rPr lang="en-US" sz="1000" dirty="0"/>
                        <a:t> fermenta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highlight>
                          <a:srgbClr val="FFFF00"/>
                        </a:highlight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highlight>
                          <a:srgbClr val="FFFF00"/>
                        </a:highlight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ym typeface="Symbol" panose="05050102010706020507" pitchFamily="18" charset="2"/>
                        </a:rPr>
                        <a:t></a:t>
                      </a:r>
                      <a:endParaRPr lang="en-US" sz="10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ym typeface="Symbol" panose="05050102010706020507" pitchFamily="18" charset="2"/>
                        </a:rPr>
                        <a:t></a:t>
                      </a:r>
                      <a:endParaRPr lang="en-US" sz="10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ym typeface="Symbol" panose="05050102010706020507" pitchFamily="18" charset="2"/>
                        </a:rPr>
                        <a:t></a:t>
                      </a:r>
                      <a:endParaRPr lang="en-US" sz="10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ym typeface="Symbol" panose="05050102010706020507" pitchFamily="18" charset="2"/>
                        </a:rPr>
                        <a:t></a:t>
                      </a:r>
                      <a:endParaRPr lang="en-US" sz="10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ym typeface="Symbol" panose="05050102010706020507" pitchFamily="18" charset="2"/>
                        </a:rPr>
                        <a:t></a:t>
                      </a:r>
                      <a:endParaRPr lang="en-US" sz="1000" b="1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483175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000" dirty="0"/>
                        <a:t> homolactic fermenta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highlight>
                          <a:srgbClr val="FFFF00"/>
                        </a:highlight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highlight>
                          <a:srgbClr val="FFFF00"/>
                        </a:highlight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ym typeface="Symbol" panose="05050102010706020507" pitchFamily="18" charset="2"/>
                        </a:rPr>
                        <a:t></a:t>
                      </a:r>
                      <a:endParaRPr lang="en-US" sz="10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ym typeface="Symbol" panose="05050102010706020507" pitchFamily="18" charset="2"/>
                        </a:rPr>
                        <a:t></a:t>
                      </a:r>
                      <a:endParaRPr lang="en-US" sz="10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7873487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D08B1EA4-A959-8F7F-0C1B-7DE547C34713}"/>
              </a:ext>
            </a:extLst>
          </p:cNvPr>
          <p:cNvSpPr txBox="1"/>
          <p:nvPr/>
        </p:nvSpPr>
        <p:spPr>
          <a:xfrm>
            <a:off x="3251405" y="3039562"/>
            <a:ext cx="1243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ctate synthesis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36BC6BA-3128-EBEB-A58B-036F920B5026}"/>
              </a:ext>
            </a:extLst>
          </p:cNvPr>
          <p:cNvSpPr/>
          <p:nvPr/>
        </p:nvSpPr>
        <p:spPr>
          <a:xfrm>
            <a:off x="1337801" y="3370280"/>
            <a:ext cx="914823" cy="416641"/>
          </a:xfrm>
          <a:prstGeom prst="rect">
            <a:avLst/>
          </a:prstGeom>
          <a:solidFill>
            <a:srgbClr val="92D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Sex: ****</a:t>
            </a:r>
          </a:p>
        </p:txBody>
      </p:sp>
      <p:sp>
        <p:nvSpPr>
          <p:cNvPr id="11" name="Left Brace 10">
            <a:extLst>
              <a:ext uri="{FF2B5EF4-FFF2-40B4-BE49-F238E27FC236}">
                <a16:creationId xmlns:a16="http://schemas.microsoft.com/office/drawing/2014/main" id="{285F9A07-CFF4-4683-31DE-FD9A8E6C12BD}"/>
              </a:ext>
            </a:extLst>
          </p:cNvPr>
          <p:cNvSpPr/>
          <p:nvPr/>
        </p:nvSpPr>
        <p:spPr>
          <a:xfrm>
            <a:off x="4475747" y="2958758"/>
            <a:ext cx="251612" cy="470242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5C3B2D2-CF57-E71B-B128-2AB52386F637}"/>
              </a:ext>
            </a:extLst>
          </p:cNvPr>
          <p:cNvSpPr txBox="1"/>
          <p:nvPr/>
        </p:nvSpPr>
        <p:spPr>
          <a:xfrm>
            <a:off x="257259" y="662027"/>
            <a:ext cx="1100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4.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A507CA3A-3318-E601-F393-7F53AD39A533}"/>
              </a:ext>
            </a:extLst>
          </p:cNvPr>
          <p:cNvCxnSpPr>
            <a:endCxn id="8" idx="1"/>
          </p:cNvCxnSpPr>
          <p:nvPr/>
        </p:nvCxnSpPr>
        <p:spPr>
          <a:xfrm>
            <a:off x="2935705" y="3176337"/>
            <a:ext cx="315700" cy="172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6555045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1CAC5ADC-EBC8-D881-DB3D-DBBD743B258B}"/>
              </a:ext>
            </a:extLst>
          </p:cNvPr>
          <p:cNvGrpSpPr/>
          <p:nvPr/>
        </p:nvGrpSpPr>
        <p:grpSpPr>
          <a:xfrm>
            <a:off x="9669903" y="3059517"/>
            <a:ext cx="1092287" cy="1127292"/>
            <a:chOff x="9258300" y="2616199"/>
            <a:chExt cx="1092287" cy="1127292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6370F1C-D5C0-0D33-20C5-49EB514C6FA0}"/>
                </a:ext>
              </a:extLst>
            </p:cNvPr>
            <p:cNvSpPr txBox="1"/>
            <p:nvPr/>
          </p:nvSpPr>
          <p:spPr>
            <a:xfrm>
              <a:off x="9258300" y="2616199"/>
              <a:ext cx="109228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/>
                <a:t>Female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AC0084F-ED70-6955-6E16-FB7C7DDA929D}"/>
                </a:ext>
              </a:extLst>
            </p:cNvPr>
            <p:cNvSpPr txBox="1"/>
            <p:nvPr/>
          </p:nvSpPr>
          <p:spPr>
            <a:xfrm>
              <a:off x="9258300" y="3281826"/>
              <a:ext cx="81945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/>
                <a:t>Male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5E65AF24-71CC-88E0-DE33-802B846AEBC9}"/>
              </a:ext>
            </a:extLst>
          </p:cNvPr>
          <p:cNvSpPr txBox="1"/>
          <p:nvPr/>
        </p:nvSpPr>
        <p:spPr>
          <a:xfrm>
            <a:off x="178438" y="232370"/>
            <a:ext cx="1254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5A.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1D769F5C-81D4-BC5D-F44A-12053BCDA88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2920"/>
          <a:stretch/>
        </p:blipFill>
        <p:spPr>
          <a:xfrm>
            <a:off x="1631527" y="-150858"/>
            <a:ext cx="7421923" cy="7008857"/>
          </a:xfrm>
          <a:prstGeom prst="rect">
            <a:avLst/>
          </a:prstGeom>
        </p:spPr>
      </p:pic>
      <p:grpSp>
        <p:nvGrpSpPr>
          <p:cNvPr id="53" name="Group 52">
            <a:extLst>
              <a:ext uri="{FF2B5EF4-FFF2-40B4-BE49-F238E27FC236}">
                <a16:creationId xmlns:a16="http://schemas.microsoft.com/office/drawing/2014/main" id="{5413DE6C-18F7-3AFC-F52D-8C1F407A4A16}"/>
              </a:ext>
            </a:extLst>
          </p:cNvPr>
          <p:cNvGrpSpPr/>
          <p:nvPr/>
        </p:nvGrpSpPr>
        <p:grpSpPr>
          <a:xfrm>
            <a:off x="9271970" y="3488531"/>
            <a:ext cx="397933" cy="830997"/>
            <a:chOff x="10136379" y="3605494"/>
            <a:chExt cx="397933" cy="830997"/>
          </a:xfrm>
        </p:grpSpPr>
        <p:sp>
          <p:nvSpPr>
            <p:cNvPr id="52" name="Oval 51">
              <a:extLst>
                <a:ext uri="{FF2B5EF4-FFF2-40B4-BE49-F238E27FC236}">
                  <a16:creationId xmlns:a16="http://schemas.microsoft.com/office/drawing/2014/main" id="{7FA4D43A-7463-4C4C-A154-902A4F336B38}"/>
                </a:ext>
              </a:extLst>
            </p:cNvPr>
            <p:cNvSpPr/>
            <p:nvPr/>
          </p:nvSpPr>
          <p:spPr>
            <a:xfrm>
              <a:off x="10144364" y="3963242"/>
              <a:ext cx="279400" cy="254000"/>
            </a:xfrm>
            <a:prstGeom prst="ellipse">
              <a:avLst/>
            </a:prstGeom>
            <a:solidFill>
              <a:srgbClr val="FFC0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A2BBA4DC-E317-8CEA-F842-906D9A57829F}"/>
                </a:ext>
              </a:extLst>
            </p:cNvPr>
            <p:cNvSpPr txBox="1"/>
            <p:nvPr/>
          </p:nvSpPr>
          <p:spPr>
            <a:xfrm>
              <a:off x="10136379" y="3605494"/>
              <a:ext cx="397933" cy="83099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4800" dirty="0">
                  <a:solidFill>
                    <a:srgbClr val="FF0000"/>
                  </a:solidFill>
                  <a:effectLst/>
                  <a:latin typeface="Tahoma" panose="020B0604030504040204" pitchFamily="34" charset="0"/>
                  <a:ea typeface="Calibri" panose="020F0502020204030204" pitchFamily="34" charset="0"/>
                </a:rPr>
                <a:t>♂</a:t>
              </a:r>
              <a:endParaRPr lang="en-US" sz="48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1AA80476-E821-2646-C6F9-3261ECAADF6C}"/>
              </a:ext>
            </a:extLst>
          </p:cNvPr>
          <p:cNvGrpSpPr/>
          <p:nvPr/>
        </p:nvGrpSpPr>
        <p:grpSpPr>
          <a:xfrm>
            <a:off x="9231463" y="2836408"/>
            <a:ext cx="329180" cy="830997"/>
            <a:chOff x="10282134" y="1917842"/>
            <a:chExt cx="329180" cy="830997"/>
          </a:xfrm>
        </p:grpSpPr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8A26EA61-1301-5E59-01CD-EA144C24EF4B}"/>
                </a:ext>
              </a:extLst>
            </p:cNvPr>
            <p:cNvSpPr/>
            <p:nvPr/>
          </p:nvSpPr>
          <p:spPr>
            <a:xfrm>
              <a:off x="10309628" y="2299500"/>
              <a:ext cx="279400" cy="254000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D5F6339-0B93-8F19-F109-32A9432297B4}"/>
                </a:ext>
              </a:extLst>
            </p:cNvPr>
            <p:cNvSpPr txBox="1"/>
            <p:nvPr/>
          </p:nvSpPr>
          <p:spPr>
            <a:xfrm rot="10800000">
              <a:off x="10282134" y="1917842"/>
              <a:ext cx="329180" cy="83099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4800" dirty="0">
                  <a:solidFill>
                    <a:srgbClr val="FF0000"/>
                  </a:solidFill>
                  <a:effectLst/>
                  <a:latin typeface="Tahoma" panose="020B0604030504040204" pitchFamily="34" charset="0"/>
                  <a:ea typeface="Calibri" panose="020F0502020204030204" pitchFamily="34" charset="0"/>
                </a:rPr>
                <a:t>♀</a:t>
              </a:r>
              <a:endParaRPr lang="en-US" sz="4800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964513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ED962AA-C1E4-BBD8-C3CA-554EDD9AC8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7900" y="609600"/>
            <a:ext cx="7696200" cy="56388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96FD4A1-3926-1D3D-90E1-1BC44F4F2816}"/>
              </a:ext>
            </a:extLst>
          </p:cNvPr>
          <p:cNvSpPr txBox="1"/>
          <p:nvPr/>
        </p:nvSpPr>
        <p:spPr>
          <a:xfrm>
            <a:off x="235994" y="240268"/>
            <a:ext cx="1225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5B.</a:t>
            </a:r>
          </a:p>
        </p:txBody>
      </p:sp>
    </p:spTree>
    <p:extLst>
      <p:ext uri="{BB962C8B-B14F-4D97-AF65-F5344CB8AC3E}">
        <p14:creationId xmlns:p14="http://schemas.microsoft.com/office/powerpoint/2010/main" val="343916104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9CDA08B-13FB-1D60-006C-DD5680005D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5150" y="614362"/>
            <a:ext cx="5981700" cy="562927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8E72BF8-63A6-030B-A191-EF2C538DFCD0}"/>
              </a:ext>
            </a:extLst>
          </p:cNvPr>
          <p:cNvSpPr txBox="1"/>
          <p:nvPr/>
        </p:nvSpPr>
        <p:spPr>
          <a:xfrm>
            <a:off x="544644" y="3796028"/>
            <a:ext cx="4214510" cy="7848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Concentration of lipid </a:t>
            </a:r>
          </a:p>
          <a:p>
            <a:r>
              <a:rPr lang="en-US" sz="11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Cellular homeostasis </a:t>
            </a:r>
          </a:p>
          <a:p>
            <a:r>
              <a:rPr lang="en-US" sz="11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Insulin Secretion Signaling Pathway </a:t>
            </a:r>
          </a:p>
          <a:p>
            <a:r>
              <a:rPr lang="en-US" sz="11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Production of </a:t>
            </a:r>
            <a:r>
              <a:rPr lang="en-US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reactive</a:t>
            </a:r>
            <a:r>
              <a:rPr lang="en-US" sz="11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oxygen species</a:t>
            </a:r>
            <a:endParaRPr lang="en-US" sz="1100" dirty="0"/>
          </a:p>
        </p:txBody>
      </p:sp>
      <p:sp>
        <p:nvSpPr>
          <p:cNvPr id="10" name="Speech Bubble: Rectangle with Corners Rounded 9">
            <a:extLst>
              <a:ext uri="{FF2B5EF4-FFF2-40B4-BE49-F238E27FC236}">
                <a16:creationId xmlns:a16="http://schemas.microsoft.com/office/drawing/2014/main" id="{0F2B2895-2B5B-CD1B-EF80-A043A7B327B9}"/>
              </a:ext>
            </a:extLst>
          </p:cNvPr>
          <p:cNvSpPr/>
          <p:nvPr/>
        </p:nvSpPr>
        <p:spPr>
          <a:xfrm>
            <a:off x="8523294" y="329884"/>
            <a:ext cx="3459599" cy="1052349"/>
          </a:xfrm>
          <a:prstGeom prst="wedgeRoundRectCallout">
            <a:avLst>
              <a:gd name="adj1" fmla="val -116759"/>
              <a:gd name="adj2" fmla="val 119843"/>
              <a:gd name="adj3" fmla="val 16667"/>
            </a:avLst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1E7FD16-AE86-031D-2EEC-CB2AE345B0F2}"/>
              </a:ext>
            </a:extLst>
          </p:cNvPr>
          <p:cNvSpPr txBox="1"/>
          <p:nvPr/>
        </p:nvSpPr>
        <p:spPr>
          <a:xfrm>
            <a:off x="8644556" y="377949"/>
            <a:ext cx="349784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Quantity of carbohydrate</a:t>
            </a:r>
          </a:p>
          <a:p>
            <a:r>
              <a:rPr lang="en-US" sz="1200" dirty="0"/>
              <a:t>Necrosis</a:t>
            </a:r>
          </a:p>
          <a:p>
            <a:r>
              <a:rPr lang="en-US" sz="1200" dirty="0"/>
              <a:t>Activation of cells</a:t>
            </a:r>
          </a:p>
          <a:p>
            <a:r>
              <a:rPr lang="en-US" sz="1200" dirty="0"/>
              <a:t>Metabolism of nucleic acid component or derivative</a:t>
            </a:r>
          </a:p>
        </p:txBody>
      </p:sp>
      <p:sp>
        <p:nvSpPr>
          <p:cNvPr id="13" name="Speech Bubble: Rectangle with Corners Rounded 12">
            <a:extLst>
              <a:ext uri="{FF2B5EF4-FFF2-40B4-BE49-F238E27FC236}">
                <a16:creationId xmlns:a16="http://schemas.microsoft.com/office/drawing/2014/main" id="{9AFF4EBA-9942-7391-462A-1818A3FFB47A}"/>
              </a:ext>
            </a:extLst>
          </p:cNvPr>
          <p:cNvSpPr/>
          <p:nvPr/>
        </p:nvSpPr>
        <p:spPr>
          <a:xfrm>
            <a:off x="371147" y="3609926"/>
            <a:ext cx="2960632" cy="1068400"/>
          </a:xfrm>
          <a:prstGeom prst="wedgeRoundRectCallout">
            <a:avLst>
              <a:gd name="adj1" fmla="val 91719"/>
              <a:gd name="adj2" fmla="val -24236"/>
              <a:gd name="adj3" fmla="val 16667"/>
            </a:avLst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14571BE-D643-6226-9337-41611A8667A9}"/>
              </a:ext>
            </a:extLst>
          </p:cNvPr>
          <p:cNvSpPr txBox="1"/>
          <p:nvPr/>
        </p:nvSpPr>
        <p:spPr>
          <a:xfrm>
            <a:off x="235994" y="240268"/>
            <a:ext cx="1100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6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A0AEBA6-5BDD-6108-A318-498AD359897C}"/>
              </a:ext>
            </a:extLst>
          </p:cNvPr>
          <p:cNvSpPr txBox="1"/>
          <p:nvPr/>
        </p:nvSpPr>
        <p:spPr>
          <a:xfrm>
            <a:off x="9086850" y="3416432"/>
            <a:ext cx="201354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Quantity of amino acids</a:t>
            </a:r>
            <a:endParaRPr lang="en-US" sz="1200" dirty="0"/>
          </a:p>
        </p:txBody>
      </p:sp>
      <p:sp>
        <p:nvSpPr>
          <p:cNvPr id="14" name="Speech Bubble: Rectangle with Corners Rounded 13">
            <a:extLst>
              <a:ext uri="{FF2B5EF4-FFF2-40B4-BE49-F238E27FC236}">
                <a16:creationId xmlns:a16="http://schemas.microsoft.com/office/drawing/2014/main" id="{F940E1C2-28B1-EB80-F754-9AF309E13A31}"/>
              </a:ext>
            </a:extLst>
          </p:cNvPr>
          <p:cNvSpPr/>
          <p:nvPr/>
        </p:nvSpPr>
        <p:spPr>
          <a:xfrm>
            <a:off x="8966103" y="3416432"/>
            <a:ext cx="2134288" cy="276999"/>
          </a:xfrm>
          <a:prstGeom prst="wedgeRoundRectCallout">
            <a:avLst>
              <a:gd name="adj1" fmla="val -140039"/>
              <a:gd name="adj2" fmla="val 103245"/>
              <a:gd name="adj3" fmla="val 16667"/>
            </a:avLst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8282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7B64A28-CEE1-3CBD-6994-92469F9C42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3531997"/>
              </p:ext>
            </p:extLst>
          </p:nvPr>
        </p:nvGraphicFramePr>
        <p:xfrm>
          <a:off x="2137144" y="871870"/>
          <a:ext cx="7621100" cy="4275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5211164" imgH="2923583" progId="Prism8.Document">
                  <p:embed/>
                </p:oleObj>
              </mc:Choice>
              <mc:Fallback>
                <p:oleObj name="Prism 8" r:id="rId2" imgW="5211164" imgH="2923583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07B64A28-CEE1-3CBD-6994-92469F9C422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137144" y="871870"/>
                        <a:ext cx="7621100" cy="4275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C47F3694-D9A6-09DD-6C29-44143D4980E6}"/>
              </a:ext>
            </a:extLst>
          </p:cNvPr>
          <p:cNvSpPr txBox="1"/>
          <p:nvPr/>
        </p:nvSpPr>
        <p:spPr>
          <a:xfrm>
            <a:off x="489099" y="261901"/>
            <a:ext cx="1234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2A.</a:t>
            </a:r>
          </a:p>
        </p:txBody>
      </p:sp>
    </p:spTree>
    <p:extLst>
      <p:ext uri="{BB962C8B-B14F-4D97-AF65-F5344CB8AC3E}">
        <p14:creationId xmlns:p14="http://schemas.microsoft.com/office/powerpoint/2010/main" val="37624800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4555DE4-ABC2-B4F9-5E3F-82363F7506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7327" y="1082674"/>
            <a:ext cx="10417346" cy="515302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C5A7EBE-C026-DB03-6C5A-E30C8D9E1A57}"/>
              </a:ext>
            </a:extLst>
          </p:cNvPr>
          <p:cNvSpPr txBox="1"/>
          <p:nvPr/>
        </p:nvSpPr>
        <p:spPr>
          <a:xfrm>
            <a:off x="214729" y="45339"/>
            <a:ext cx="1225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2B.</a:t>
            </a:r>
          </a:p>
        </p:txBody>
      </p:sp>
    </p:spTree>
    <p:extLst>
      <p:ext uri="{BB962C8B-B14F-4D97-AF65-F5344CB8AC3E}">
        <p14:creationId xmlns:p14="http://schemas.microsoft.com/office/powerpoint/2010/main" val="13272614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DC001E5-255D-4D9D-448F-C0812E4498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7700" y="1489074"/>
            <a:ext cx="10499032" cy="434022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BF5EA37-B38E-EE6A-09DF-74AC3D83E43B}"/>
              </a:ext>
            </a:extLst>
          </p:cNvPr>
          <p:cNvSpPr txBox="1"/>
          <p:nvPr/>
        </p:nvSpPr>
        <p:spPr>
          <a:xfrm>
            <a:off x="204096" y="747088"/>
            <a:ext cx="1223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2C.</a:t>
            </a:r>
          </a:p>
        </p:txBody>
      </p:sp>
    </p:spTree>
    <p:extLst>
      <p:ext uri="{BB962C8B-B14F-4D97-AF65-F5344CB8AC3E}">
        <p14:creationId xmlns:p14="http://schemas.microsoft.com/office/powerpoint/2010/main" val="2862983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F6972BE-B6D9-9502-A875-E82146585F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4250" y="1590674"/>
            <a:ext cx="10898260" cy="432752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09A6D28-BA03-47D0-3062-423729E2D3E7}"/>
              </a:ext>
            </a:extLst>
          </p:cNvPr>
          <p:cNvSpPr txBox="1"/>
          <p:nvPr/>
        </p:nvSpPr>
        <p:spPr>
          <a:xfrm>
            <a:off x="257259" y="662027"/>
            <a:ext cx="12374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2D.</a:t>
            </a:r>
          </a:p>
        </p:txBody>
      </p:sp>
    </p:spTree>
    <p:extLst>
      <p:ext uri="{BB962C8B-B14F-4D97-AF65-F5344CB8AC3E}">
        <p14:creationId xmlns:p14="http://schemas.microsoft.com/office/powerpoint/2010/main" val="21485888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189E165C-F471-93A1-A016-08CF3D6B40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1357634"/>
              </p:ext>
            </p:extLst>
          </p:nvPr>
        </p:nvGraphicFramePr>
        <p:xfrm>
          <a:off x="1060449" y="1020763"/>
          <a:ext cx="10499343" cy="414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7429240" imgH="2935464" progId="Prism8.Document">
                  <p:embed/>
                </p:oleObj>
              </mc:Choice>
              <mc:Fallback>
                <p:oleObj name="Prism 8" r:id="rId2" imgW="7429240" imgH="2935464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189E165C-F471-93A1-A016-08CF3D6B40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60449" y="1020763"/>
                        <a:ext cx="10499343" cy="414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8C90C3D5-2701-6A55-E499-B8F76FD585B1}"/>
              </a:ext>
            </a:extLst>
          </p:cNvPr>
          <p:cNvSpPr txBox="1"/>
          <p:nvPr/>
        </p:nvSpPr>
        <p:spPr>
          <a:xfrm>
            <a:off x="257259" y="662027"/>
            <a:ext cx="12123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2E.</a:t>
            </a:r>
          </a:p>
        </p:txBody>
      </p:sp>
    </p:spTree>
    <p:extLst>
      <p:ext uri="{BB962C8B-B14F-4D97-AF65-F5344CB8AC3E}">
        <p14:creationId xmlns:p14="http://schemas.microsoft.com/office/powerpoint/2010/main" val="14445388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88407BF-0DF4-D684-2988-631AE45D84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8259" y="476834"/>
            <a:ext cx="6370656" cy="544830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3062F2B-DA42-45E4-BA05-8BDA8DEEDE64}"/>
              </a:ext>
            </a:extLst>
          </p:cNvPr>
          <p:cNvSpPr txBox="1"/>
          <p:nvPr/>
        </p:nvSpPr>
        <p:spPr>
          <a:xfrm>
            <a:off x="716097" y="382923"/>
            <a:ext cx="1234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3A.</a:t>
            </a:r>
          </a:p>
        </p:txBody>
      </p:sp>
    </p:spTree>
    <p:extLst>
      <p:ext uri="{BB962C8B-B14F-4D97-AF65-F5344CB8AC3E}">
        <p14:creationId xmlns:p14="http://schemas.microsoft.com/office/powerpoint/2010/main" val="380207862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4600F2A-AD29-31F9-B59D-97789C47C3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54561" y="368792"/>
            <a:ext cx="6666718" cy="570150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325E08AD-FEC6-75C1-D977-93A563FE032F}"/>
              </a:ext>
            </a:extLst>
          </p:cNvPr>
          <p:cNvSpPr txBox="1"/>
          <p:nvPr/>
        </p:nvSpPr>
        <p:spPr>
          <a:xfrm>
            <a:off x="928621" y="283772"/>
            <a:ext cx="1225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3B.</a:t>
            </a:r>
          </a:p>
        </p:txBody>
      </p:sp>
    </p:spTree>
    <p:extLst>
      <p:ext uri="{BB962C8B-B14F-4D97-AF65-F5344CB8AC3E}">
        <p14:creationId xmlns:p14="http://schemas.microsoft.com/office/powerpoint/2010/main" val="36815209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E5E99B36-FF13-6F7E-B10B-5D7E5BC01D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01957" y="893647"/>
            <a:ext cx="6135863" cy="514359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817ACB3-6EF3-37AE-DC44-AFEAD7300141}"/>
              </a:ext>
            </a:extLst>
          </p:cNvPr>
          <p:cNvSpPr txBox="1"/>
          <p:nvPr/>
        </p:nvSpPr>
        <p:spPr>
          <a:xfrm>
            <a:off x="1313824" y="893647"/>
            <a:ext cx="1223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3C.</a:t>
            </a:r>
          </a:p>
        </p:txBody>
      </p:sp>
    </p:spTree>
    <p:extLst>
      <p:ext uri="{BB962C8B-B14F-4D97-AF65-F5344CB8AC3E}">
        <p14:creationId xmlns:p14="http://schemas.microsoft.com/office/powerpoint/2010/main" val="17430955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8903a443-af33-4ed4-acf5-ee613bcb2f59}" enabled="0" method="" siteId="{8903a443-af33-4ed4-acf5-ee613bcb2f59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55794</TotalTime>
  <Words>126</Words>
  <Application>Microsoft Office PowerPoint</Application>
  <PresentationFormat>Widescreen</PresentationFormat>
  <Paragraphs>56</Paragraphs>
  <Slides>1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2" baseType="lpstr">
      <vt:lpstr>Arial</vt:lpstr>
      <vt:lpstr>Calibri</vt:lpstr>
      <vt:lpstr>Calibri Light</vt:lpstr>
      <vt:lpstr>Symbol</vt:lpstr>
      <vt:lpstr>Tahoma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H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ke, Allison V CTR USARMY MEDCOM WRAIR (US)</dc:creator>
  <cp:lastModifiedBy>Chakraborty, Nabarun CIV DHA WRAIR (USA)</cp:lastModifiedBy>
  <cp:revision>19</cp:revision>
  <dcterms:created xsi:type="dcterms:W3CDTF">2021-10-08T18:15:10Z</dcterms:created>
  <dcterms:modified xsi:type="dcterms:W3CDTF">2025-04-22T02:38:18Z</dcterms:modified>
</cp:coreProperties>
</file>